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74" r:id="rId2"/>
    <p:sldId id="375" r:id="rId3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ianhong Li" initials="TL" lastIdx="1" clrIdx="0">
    <p:extLst>
      <p:ext uri="{19B8F6BF-5375-455C-9EA6-DF929625EA0E}">
        <p15:presenceInfo xmlns:p15="http://schemas.microsoft.com/office/powerpoint/2012/main" userId="S::thli@ucdavis.edu::bccd8240-7a1e-4c6f-a0da-15fba1327b2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71" autoAdjust="0"/>
    <p:restoredTop sz="89392" autoAdjust="0"/>
  </p:normalViewPr>
  <p:slideViewPr>
    <p:cSldViewPr>
      <p:cViewPr varScale="1">
        <p:scale>
          <a:sx n="124" d="100"/>
          <a:sy n="124" d="100"/>
        </p:scale>
        <p:origin x="880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7313" y="0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783B41-E252-4750-8069-75ED7918384F}" type="datetimeFigureOut">
              <a:rPr lang="en-US" smtClean="0"/>
              <a:t>5/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7313" y="8829675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CF2379-A929-444F-B850-E0BC62BAF2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36500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7429160E-A280-4AF3-BB6B-75775C36C9B3}" type="datetimeFigureOut">
              <a:rPr lang="en-US" smtClean="0"/>
              <a:t>5/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B62B5BE4-8B39-4EC9-826B-8E28D109AF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602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2B5BE4-8B39-4EC9-826B-8E28D109AF9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9354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198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483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375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877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053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33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956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674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978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19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505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5AC7E-CF8C-4958-9D08-0B912D0CA860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EDED7-B956-469D-ABD0-BF33E3EEEF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566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8.png"/><Relationship Id="rId18" Type="http://schemas.openxmlformats.org/officeDocument/2006/relationships/image" Target="../media/image11.jpeg"/><Relationship Id="rId3" Type="http://schemas.openxmlformats.org/officeDocument/2006/relationships/image" Target="../media/image1.jpeg"/><Relationship Id="rId21" Type="http://schemas.microsoft.com/office/2007/relationships/hdphoto" Target="../media/hdphoto7.wdp"/><Relationship Id="rId7" Type="http://schemas.microsoft.com/office/2007/relationships/hdphoto" Target="../media/hdphoto1.wdp"/><Relationship Id="rId12" Type="http://schemas.openxmlformats.org/officeDocument/2006/relationships/image" Target="../media/image7.png"/><Relationship Id="rId1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microsoft.com/office/2007/relationships/hdphoto" Target="../media/hdphoto5.wdp"/><Relationship Id="rId20" Type="http://schemas.openxmlformats.org/officeDocument/2006/relationships/image" Target="../media/image1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microsoft.com/office/2007/relationships/hdphoto" Target="../media/hdphoto3.wdp"/><Relationship Id="rId5" Type="http://schemas.openxmlformats.org/officeDocument/2006/relationships/image" Target="../media/image3.png"/><Relationship Id="rId15" Type="http://schemas.openxmlformats.org/officeDocument/2006/relationships/image" Target="../media/image9.png"/><Relationship Id="rId10" Type="http://schemas.openxmlformats.org/officeDocument/2006/relationships/image" Target="../media/image6.jpeg"/><Relationship Id="rId19" Type="http://schemas.microsoft.com/office/2007/relationships/hdphoto" Target="../media/hdphoto6.wdp"/><Relationship Id="rId4" Type="http://schemas.openxmlformats.org/officeDocument/2006/relationships/image" Target="../media/image2.png"/><Relationship Id="rId9" Type="http://schemas.microsoft.com/office/2007/relationships/hdphoto" Target="../media/hdphoto2.wdp"/><Relationship Id="rId14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EVOS0050.bmp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" b="-4283"/>
          <a:stretch/>
        </p:blipFill>
        <p:spPr>
          <a:xfrm>
            <a:off x="740560" y="1413339"/>
            <a:ext cx="1992601" cy="1558461"/>
          </a:xfrm>
          <a:prstGeom prst="rect">
            <a:avLst/>
          </a:prstGeom>
        </p:spPr>
      </p:pic>
      <p:pic>
        <p:nvPicPr>
          <p:cNvPr id="5" name="图片 4" descr="EVOS0053.bmp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35041" y="1418950"/>
            <a:ext cx="2036837" cy="1470274"/>
          </a:xfrm>
          <a:prstGeom prst="rect">
            <a:avLst/>
          </a:prstGeom>
        </p:spPr>
      </p:pic>
      <p:pic>
        <p:nvPicPr>
          <p:cNvPr id="6" name="图片 5" descr="EVOS0055.bmp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3023" b="-1236"/>
          <a:stretch/>
        </p:blipFill>
        <p:spPr>
          <a:xfrm>
            <a:off x="4771925" y="1371600"/>
            <a:ext cx="1948954" cy="1524000"/>
          </a:xfrm>
          <a:prstGeom prst="rect">
            <a:avLst/>
          </a:prstGeom>
        </p:spPr>
      </p:pic>
      <p:pic>
        <p:nvPicPr>
          <p:cNvPr id="8" name="图片 7" descr="EVOS0054.bmp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b="815"/>
          <a:stretch/>
        </p:blipFill>
        <p:spPr>
          <a:xfrm>
            <a:off x="2752299" y="1413339"/>
            <a:ext cx="1992601" cy="1482261"/>
          </a:xfrm>
          <a:prstGeom prst="rect">
            <a:avLst/>
          </a:prstGeom>
        </p:spPr>
      </p:pic>
      <p:pic>
        <p:nvPicPr>
          <p:cNvPr id="13" name="图片 12" descr="EVOS0061.bmp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53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42105" y="2911226"/>
            <a:ext cx="2046546" cy="1495604"/>
          </a:xfrm>
          <a:prstGeom prst="rect">
            <a:avLst/>
          </a:prstGeom>
        </p:spPr>
      </p:pic>
      <p:pic>
        <p:nvPicPr>
          <p:cNvPr id="14" name="图片 13" descr="EVOS0066.bmp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3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81791" y="2917225"/>
            <a:ext cx="1939223" cy="1498441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1013227" y="1081205"/>
            <a:ext cx="15676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211864" y="1081641"/>
            <a:ext cx="1241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XY30 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010099" y="1094427"/>
            <a:ext cx="15676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XW64 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959053" y="1087258"/>
            <a:ext cx="17165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XY30 + LXW64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22969" y="2032138"/>
            <a:ext cx="5760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kumimoji="1"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02935" y="3479844"/>
            <a:ext cx="7499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kumimoji="1"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828042" y="1494415"/>
            <a:ext cx="672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x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366067" y="4673429"/>
            <a:ext cx="672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/>
              <a:t>10x</a:t>
            </a:r>
            <a:endParaRPr kumimoji="1" lang="zh-CN" altLang="en-US" sz="800" dirty="0"/>
          </a:p>
        </p:txBody>
      </p:sp>
      <p:sp>
        <p:nvSpPr>
          <p:cNvPr id="30" name="文本框 29"/>
          <p:cNvSpPr txBox="1"/>
          <p:nvPr/>
        </p:nvSpPr>
        <p:spPr>
          <a:xfrm>
            <a:off x="4454495" y="4673429"/>
            <a:ext cx="672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dirty="0"/>
              <a:t>10x</a:t>
            </a:r>
            <a:endParaRPr kumimoji="1" lang="zh-CN" altLang="en-US" sz="800" dirty="0"/>
          </a:p>
        </p:txBody>
      </p:sp>
      <p:pic>
        <p:nvPicPr>
          <p:cNvPr id="3" name="图片 2" descr="EVOS0067.bmp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17981" b="-4271"/>
          <a:stretch/>
        </p:blipFill>
        <p:spPr>
          <a:xfrm>
            <a:off x="726747" y="4191000"/>
            <a:ext cx="1992601" cy="1764233"/>
          </a:xfrm>
          <a:prstGeom prst="rect">
            <a:avLst/>
          </a:prstGeom>
        </p:spPr>
      </p:pic>
      <p:pic>
        <p:nvPicPr>
          <p:cNvPr id="7" name="图片 6" descr="EVOS0072.bmp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colorTemperature colorTemp="5300"/>
                    </a14:imgEffect>
                    <a14:imgEffect>
                      <a14:saturation sat="66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211" r="1402" b="1"/>
          <a:stretch/>
        </p:blipFill>
        <p:spPr>
          <a:xfrm>
            <a:off x="2763457" y="4419600"/>
            <a:ext cx="1960944" cy="1477743"/>
          </a:xfrm>
          <a:prstGeom prst="rect">
            <a:avLst/>
          </a:prstGeom>
        </p:spPr>
      </p:pic>
      <p:pic>
        <p:nvPicPr>
          <p:cNvPr id="9" name="图片 8" descr="EVOS0070.bmp"/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53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77548" y="4437020"/>
            <a:ext cx="1947707" cy="1460780"/>
          </a:xfrm>
          <a:prstGeom prst="rect">
            <a:avLst/>
          </a:prstGeom>
        </p:spPr>
      </p:pic>
      <p:pic>
        <p:nvPicPr>
          <p:cNvPr id="12" name="图片 11" descr="EVOS0071.bmp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1" b="-1585"/>
          <a:stretch/>
        </p:blipFill>
        <p:spPr>
          <a:xfrm>
            <a:off x="6749749" y="4423955"/>
            <a:ext cx="2033706" cy="1494719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90329" y="4888873"/>
            <a:ext cx="7499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kumimoji="1"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E3C4D9F-DD12-422C-A9A2-833CABE87D21}"/>
              </a:ext>
            </a:extLst>
          </p:cNvPr>
          <p:cNvSpPr txBox="1"/>
          <p:nvPr/>
        </p:nvSpPr>
        <p:spPr>
          <a:xfrm>
            <a:off x="357351" y="457482"/>
            <a:ext cx="5724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 Morphology:					</a:t>
            </a:r>
          </a:p>
        </p:txBody>
      </p:sp>
      <p:pic>
        <p:nvPicPr>
          <p:cNvPr id="11" name="图片 10" descr="EVOS0060.bmp"/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colorTemperature colorTemp="53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1" r="1677" b="-78"/>
          <a:stretch/>
        </p:blipFill>
        <p:spPr>
          <a:xfrm>
            <a:off x="2753948" y="2919999"/>
            <a:ext cx="1970452" cy="1499601"/>
          </a:xfrm>
          <a:prstGeom prst="rect">
            <a:avLst/>
          </a:prstGeom>
        </p:spPr>
      </p:pic>
      <p:pic>
        <p:nvPicPr>
          <p:cNvPr id="10" name="图片 9" descr="EVOS0057.bmp"/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colorTemperature colorTemp="59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6747" y="2927127"/>
            <a:ext cx="1992601" cy="1494451"/>
          </a:xfrm>
          <a:prstGeom prst="rect">
            <a:avLst/>
          </a:prstGeom>
        </p:spPr>
      </p:pic>
      <p:sp>
        <p:nvSpPr>
          <p:cNvPr id="34" name="矩形 1776">
            <a:extLst>
              <a:ext uri="{FF2B5EF4-FFF2-40B4-BE49-F238E27FC236}">
                <a16:creationId xmlns:a16="http://schemas.microsoft.com/office/drawing/2014/main" id="{116339F9-AD08-43DE-AC55-46AD7C2BF91B}"/>
              </a:ext>
            </a:extLst>
          </p:cNvPr>
          <p:cNvSpPr/>
          <p:nvPr/>
        </p:nvSpPr>
        <p:spPr>
          <a:xfrm>
            <a:off x="-26773" y="6222"/>
            <a:ext cx="1300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charset="0"/>
              </a:rPr>
              <a:t>Figure S2 </a:t>
            </a:r>
            <a:endParaRPr lang="zh-CN" altLang="en-US" dirty="0"/>
          </a:p>
        </p:txBody>
      </p:sp>
      <p:cxnSp>
        <p:nvCxnSpPr>
          <p:cNvPr id="22" name="Straight Connector 21"/>
          <p:cNvCxnSpPr/>
          <p:nvPr/>
        </p:nvCxnSpPr>
        <p:spPr>
          <a:xfrm flipV="1">
            <a:off x="726747" y="1419759"/>
            <a:ext cx="8045131" cy="13222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722334" y="2897981"/>
            <a:ext cx="8045131" cy="1322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711983" y="4431590"/>
            <a:ext cx="8045131" cy="1322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768279" y="1413596"/>
            <a:ext cx="8045131" cy="1322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736371" y="5875456"/>
            <a:ext cx="8045131" cy="13222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2733161" y="1432981"/>
            <a:ext cx="0" cy="44490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731703" y="1451300"/>
            <a:ext cx="0" cy="44490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753637" y="1419759"/>
            <a:ext cx="0" cy="44490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6735041" y="1439592"/>
            <a:ext cx="0" cy="44490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8767465" y="1413339"/>
            <a:ext cx="0" cy="44490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712618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135066" y="777700"/>
            <a:ext cx="4728038" cy="4065025"/>
            <a:chOff x="1088411" y="731045"/>
            <a:chExt cx="4728038" cy="4065025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D5EBD792-6D4A-4542-9189-BE2473ACF4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17330"/>
            <a:stretch/>
          </p:blipFill>
          <p:spPr>
            <a:xfrm>
              <a:off x="1447800" y="731045"/>
              <a:ext cx="4267200" cy="3788026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1088411" y="1157532"/>
              <a:ext cx="4728038" cy="3638538"/>
              <a:chOff x="1088411" y="1157532"/>
              <a:chExt cx="4728038" cy="3638538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45FBE5AA-7125-5647-84F8-17BED8E8CEFF}"/>
                  </a:ext>
                </a:extLst>
              </p:cNvPr>
              <p:cNvSpPr txBox="1"/>
              <p:nvPr/>
            </p:nvSpPr>
            <p:spPr>
              <a:xfrm>
                <a:off x="3117767" y="4519071"/>
                <a:ext cx="12051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Hours)</a:t>
                </a:r>
                <a:endParaRPr kumimoji="1"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40F6EAC0-9A73-1E48-BD42-4D9BB80CA9FF}"/>
                  </a:ext>
                </a:extLst>
              </p:cNvPr>
              <p:cNvSpPr txBox="1"/>
              <p:nvPr/>
            </p:nvSpPr>
            <p:spPr>
              <a:xfrm rot="16200000">
                <a:off x="151194" y="2693897"/>
                <a:ext cx="21514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ell</a:t>
                </a:r>
                <a:r>
                  <a:rPr kumimoji="1"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s</a:t>
                </a:r>
                <a:r>
                  <a:rPr kumimoji="1"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1x10</a:t>
                </a:r>
                <a:r>
                  <a:rPr kumimoji="1" lang="en-US" altLang="zh-CN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kumimoji="1"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/cm</a:t>
                </a:r>
                <a:r>
                  <a:rPr kumimoji="1" lang="en-US" altLang="zh-CN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umimoji="1" lang="zh-CN" alt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F61BFD73-057C-6345-871E-3BF79AF29491}"/>
                  </a:ext>
                </a:extLst>
              </p:cNvPr>
              <p:cNvSpPr txBox="1"/>
              <p:nvPr/>
            </p:nvSpPr>
            <p:spPr>
              <a:xfrm>
                <a:off x="2696822" y="1166933"/>
                <a:ext cx="1199064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  <a:p>
                <a:r>
                  <a:rPr kumimoji="1"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XY30</a:t>
                </a:r>
              </a:p>
              <a:p>
                <a:r>
                  <a:rPr kumimoji="1"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XW64</a:t>
                </a:r>
              </a:p>
              <a:p>
                <a:r>
                  <a:rPr kumimoji="1"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XW30+LXW64</a:t>
                </a:r>
                <a:endParaRPr kumimoji="1"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左中括号 11">
                <a:extLst>
                  <a:ext uri="{FF2B5EF4-FFF2-40B4-BE49-F238E27FC236}">
                    <a16:creationId xmlns:a16="http://schemas.microsoft.com/office/drawing/2014/main" id="{7D2E5A3D-D170-F54B-AA21-B9DE72472890}"/>
                  </a:ext>
                </a:extLst>
              </p:cNvPr>
              <p:cNvSpPr/>
              <p:nvPr/>
            </p:nvSpPr>
            <p:spPr>
              <a:xfrm rot="10800000">
                <a:off x="5442822" y="2110471"/>
                <a:ext cx="45719" cy="461666"/>
              </a:xfrm>
              <a:prstGeom prst="lef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 sz="2000" b="1" dirty="0"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左中括号 13">
                <a:extLst>
                  <a:ext uri="{FF2B5EF4-FFF2-40B4-BE49-F238E27FC236}">
                    <a16:creationId xmlns:a16="http://schemas.microsoft.com/office/drawing/2014/main" id="{D77E77D8-79BA-6843-9284-EBC7C6FB367C}"/>
                  </a:ext>
                </a:extLst>
              </p:cNvPr>
              <p:cNvSpPr/>
              <p:nvPr/>
            </p:nvSpPr>
            <p:spPr>
              <a:xfrm rot="10800000">
                <a:off x="5299163" y="1918264"/>
                <a:ext cx="45719" cy="187343"/>
              </a:xfrm>
              <a:prstGeom prst="lef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 sz="2000" b="1" dirty="0"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矩形 1">
                <a:extLst>
                  <a:ext uri="{FF2B5EF4-FFF2-40B4-BE49-F238E27FC236}">
                    <a16:creationId xmlns:a16="http://schemas.microsoft.com/office/drawing/2014/main" id="{528EC238-049A-4648-8C7B-CCADE0B58B8E}"/>
                  </a:ext>
                </a:extLst>
              </p:cNvPr>
              <p:cNvSpPr/>
              <p:nvPr/>
            </p:nvSpPr>
            <p:spPr>
              <a:xfrm>
                <a:off x="5304125" y="1882953"/>
                <a:ext cx="346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 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">
                <a:extLst>
                  <a:ext uri="{FF2B5EF4-FFF2-40B4-BE49-F238E27FC236}">
                    <a16:creationId xmlns:a16="http://schemas.microsoft.com/office/drawing/2014/main" id="{528EC238-049A-4648-8C7B-CCADE0B58B8E}"/>
                  </a:ext>
                </a:extLst>
              </p:cNvPr>
              <p:cNvSpPr/>
              <p:nvPr/>
            </p:nvSpPr>
            <p:spPr>
              <a:xfrm>
                <a:off x="5469879" y="2099217"/>
                <a:ext cx="346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 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62200" y="1157532"/>
                <a:ext cx="390525" cy="771525"/>
              </a:xfrm>
              <a:prstGeom prst="rect">
                <a:avLst/>
              </a:prstGeom>
            </p:spPr>
          </p:pic>
        </p:grpSp>
      </p:grpSp>
      <p:sp>
        <p:nvSpPr>
          <p:cNvPr id="18" name="矩形 1776">
            <a:extLst>
              <a:ext uri="{FF2B5EF4-FFF2-40B4-BE49-F238E27FC236}">
                <a16:creationId xmlns:a16="http://schemas.microsoft.com/office/drawing/2014/main" id="{116339F9-AD08-43DE-AC55-46AD7C2BF91B}"/>
              </a:ext>
            </a:extLst>
          </p:cNvPr>
          <p:cNvSpPr/>
          <p:nvPr/>
        </p:nvSpPr>
        <p:spPr>
          <a:xfrm>
            <a:off x="6550297" y="-20002"/>
            <a:ext cx="2723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charset="0"/>
              </a:rPr>
              <a:t>Figure S2 (Continued) </a:t>
            </a:r>
            <a:endParaRPr lang="zh-CN" alt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E3C4D9F-DD12-422C-A9A2-833CABE87D21}"/>
              </a:ext>
            </a:extLst>
          </p:cNvPr>
          <p:cNvSpPr txBox="1"/>
          <p:nvPr/>
        </p:nvSpPr>
        <p:spPr>
          <a:xfrm>
            <a:off x="357351" y="457482"/>
            <a:ext cx="5724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 Cell proliferation:					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AC5FBF0-5230-264A-B789-10B5126E6D89}"/>
              </a:ext>
            </a:extLst>
          </p:cNvPr>
          <p:cNvSpPr txBox="1"/>
          <p:nvPr/>
        </p:nvSpPr>
        <p:spPr>
          <a:xfrm>
            <a:off x="4798064" y="2961753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* </a:t>
            </a:r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5817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6</TotalTime>
  <Words>59</Words>
  <Application>Microsoft Macintosh PowerPoint</Application>
  <PresentationFormat>全屏显示(4:3)</PresentationFormat>
  <Paragraphs>24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演示文稿</vt:lpstr>
      <vt:lpstr>PowerPoint 演示文稿</vt:lpstr>
    </vt:vector>
  </TitlesOfParts>
  <Company>UCD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ants for Blood biomarkers</dc:title>
  <dc:creator>ntwadmin</dc:creator>
  <cp:lastModifiedBy>Microsoft Office User</cp:lastModifiedBy>
  <cp:revision>462</cp:revision>
  <cp:lastPrinted>2019-01-17T07:37:07Z</cp:lastPrinted>
  <dcterms:created xsi:type="dcterms:W3CDTF">2016-07-02T09:55:06Z</dcterms:created>
  <dcterms:modified xsi:type="dcterms:W3CDTF">2019-05-03T06:37:17Z</dcterms:modified>
</cp:coreProperties>
</file>